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7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E76182-03E0-4BA5-A9A6-75728A55154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3EDBDC-38E1-46DA-B90F-14132E30C6E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73DAB2-8DD6-497D-93C2-6BA12476911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0E5BC3-F174-41DD-AEE6-A9125B8283E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E1218C-089B-4BE5-A47D-D738F808FDC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8B96B4-092D-45E9-B0C8-C25AAD4EA00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3C1D3A-B029-47B2-970C-F2DE92B2FAF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682898-CA83-4399-928D-335F5EF310F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A021B7-D9D0-4EE2-B911-B6D1F8FAF59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CC304E-CE66-4DE9-B170-511B65F3503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40F620-5B13-4C19-9625-3DB7E550C0C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0BC25D-A2E6-42C5-9FFB-2D279897441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AABB3E4-1904-4979-AD30-88BE7B37C096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5.png"/><Relationship Id="rId9" Type="http://schemas.openxmlformats.org/officeDocument/2006/relationships/image" Target="../media/image5.png"/><Relationship Id="rId10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rcRect l="0" t="58374" r="0" b="4176"/>
          <a:stretch/>
        </p:blipFill>
        <p:spPr>
          <a:xfrm>
            <a:off x="2243160" y="914400"/>
            <a:ext cx="2119320" cy="514440"/>
          </a:xfrm>
          <a:prstGeom prst="rect">
            <a:avLst/>
          </a:prstGeom>
          <a:ln w="0">
            <a:noFill/>
          </a:ln>
        </p:spPr>
      </p:pic>
      <p:sp>
        <p:nvSpPr>
          <p:cNvPr id="42" name=""/>
          <p:cNvSpPr/>
          <p:nvPr/>
        </p:nvSpPr>
        <p:spPr>
          <a:xfrm>
            <a:off x="2273400" y="1212840"/>
            <a:ext cx="2209680" cy="118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Fos, Jun, Fra1, Atf3, Arc, Mig6, Nr4a1, Ereg, Hbegf, Edn1 Cxcl1, Cyr61, Csf1, Cox2, Pai-1,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Plaur, Ccrn4l, Sgk1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3" name="" descr=""/>
          <p:cNvPicPr/>
          <p:nvPr/>
        </p:nvPicPr>
        <p:blipFill>
          <a:blip r:embed="rId2"/>
          <a:srcRect l="0" t="40040" r="0" b="0"/>
          <a:stretch/>
        </p:blipFill>
        <p:spPr>
          <a:xfrm>
            <a:off x="2257560" y="2793960"/>
            <a:ext cx="2133360" cy="1219320"/>
          </a:xfrm>
          <a:prstGeom prst="rect">
            <a:avLst/>
          </a:prstGeom>
          <a:ln w="0">
            <a:noFill/>
          </a:ln>
        </p:spPr>
      </p:pic>
      <p:sp>
        <p:nvSpPr>
          <p:cNvPr id="44" name=""/>
          <p:cNvSpPr/>
          <p:nvPr/>
        </p:nvSpPr>
        <p:spPr>
          <a:xfrm>
            <a:off x="2266920" y="4032360"/>
            <a:ext cx="2282760" cy="1004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Zfp36, Mcl1, Hes1, Gly96,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Id3, Myd116, Egr4, Dusp1, Ier5, Btg2, Nfkbia,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Vcam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476280" y="3295800"/>
            <a:ext cx="1677960" cy="0"/>
          </a:xfrm>
          <a:prstGeom prst="line">
            <a:avLst/>
          </a:prstGeom>
          <a:ln w="19080">
            <a:solidFill>
              <a:srgbClr val="333399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685800" y="-152280"/>
            <a:ext cx="3733920" cy="99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800" spc="-1" strike="noStrike">
                <a:solidFill>
                  <a:srgbClr val="000000"/>
                </a:solidFill>
                <a:latin typeface="Arial"/>
              </a:rPr>
              <a:t>Immediate-early genes 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7" name="" descr=""/>
          <p:cNvPicPr/>
          <p:nvPr/>
        </p:nvPicPr>
        <p:blipFill>
          <a:blip r:embed="rId3"/>
          <a:srcRect l="0" t="0" r="83055" b="95217"/>
          <a:stretch/>
        </p:blipFill>
        <p:spPr>
          <a:xfrm>
            <a:off x="2286000" y="4889520"/>
            <a:ext cx="2119320" cy="520560"/>
          </a:xfrm>
          <a:prstGeom prst="rect">
            <a:avLst/>
          </a:prstGeom>
          <a:ln w="0">
            <a:noFill/>
          </a:ln>
        </p:spPr>
      </p:pic>
      <p:sp>
        <p:nvSpPr>
          <p:cNvPr id="48" name=""/>
          <p:cNvSpPr/>
          <p:nvPr/>
        </p:nvSpPr>
        <p:spPr>
          <a:xfrm>
            <a:off x="552600" y="1219320"/>
            <a:ext cx="457200" cy="0"/>
          </a:xfrm>
          <a:prstGeom prst="line">
            <a:avLst/>
          </a:prstGeom>
          <a:ln w="12600">
            <a:solidFill>
              <a:srgbClr val="ddddd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9" name=""/>
          <p:cNvGrpSpPr/>
          <p:nvPr/>
        </p:nvGrpSpPr>
        <p:grpSpPr>
          <a:xfrm>
            <a:off x="171360" y="901800"/>
            <a:ext cx="2032200" cy="1828800"/>
            <a:chOff x="171360" y="901800"/>
            <a:chExt cx="2032200" cy="1828800"/>
          </a:xfrm>
        </p:grpSpPr>
        <p:pic>
          <p:nvPicPr>
            <p:cNvPr id="50" name="" descr=""/>
            <p:cNvPicPr/>
            <p:nvPr/>
          </p:nvPicPr>
          <p:blipFill>
            <a:blip r:embed="rId4"/>
            <a:srcRect l="-1009" t="0" r="74634" b="70096"/>
            <a:stretch/>
          </p:blipFill>
          <p:spPr>
            <a:xfrm>
              <a:off x="304920" y="901800"/>
              <a:ext cx="1898640" cy="18288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1" name=""/>
            <p:cNvSpPr/>
            <p:nvPr/>
          </p:nvSpPr>
          <p:spPr>
            <a:xfrm>
              <a:off x="465840" y="1808280"/>
              <a:ext cx="799200" cy="304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nl-NL" sz="1400" spc="-1" strike="noStrike">
                  <a:solidFill>
                    <a:srgbClr val="000000"/>
                  </a:solidFill>
                  <a:latin typeface="Arial"/>
                </a:rPr>
                <a:t>0.5-6 hr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695520" y="1527120"/>
              <a:ext cx="152280" cy="304920"/>
            </a:xfrm>
            <a:prstGeom prst="upArrow">
              <a:avLst>
                <a:gd name="adj1" fmla="val 50000"/>
                <a:gd name="adj2" fmla="val 50059"/>
              </a:avLst>
            </a:prstGeom>
            <a:solidFill>
              <a:srgbClr val="ff33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237960" y="1003320"/>
              <a:ext cx="268920" cy="274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333399"/>
                  </a:solidFill>
                  <a:latin typeface="Arial"/>
                </a:rPr>
                <a:t>4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237960" y="1359000"/>
              <a:ext cx="268920" cy="274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333399"/>
                  </a:solidFill>
                  <a:latin typeface="Arial"/>
                </a:rPr>
                <a:t>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190440" y="2035080"/>
              <a:ext cx="319320" cy="274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333399"/>
                  </a:solidFill>
                  <a:latin typeface="Arial"/>
                </a:rPr>
                <a:t>-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171360" y="2382840"/>
              <a:ext cx="319320" cy="274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333399"/>
                  </a:solidFill>
                  <a:latin typeface="Arial"/>
                </a:rPr>
                <a:t>-4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1317240" y="2374920"/>
              <a:ext cx="8359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200" spc="-1" strike="noStrike">
                  <a:solidFill>
                    <a:srgbClr val="003399"/>
                  </a:solidFill>
                  <a:latin typeface="Arial"/>
                </a:rPr>
                <a:t>31 gene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558720" y="1081080"/>
              <a:ext cx="419040" cy="1015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"/>
            <p:cNvSpPr/>
            <p:nvPr/>
          </p:nvSpPr>
          <p:spPr>
            <a:xfrm flipV="1">
              <a:off x="552600" y="1144080"/>
              <a:ext cx="457200" cy="57240"/>
            </a:xfrm>
            <a:prstGeom prst="line">
              <a:avLst/>
            </a:prstGeom>
            <a:ln w="12600">
              <a:solidFill>
                <a:srgbClr val="dddddd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440" bIns="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"/>
            <p:cNvSpPr/>
            <p:nvPr/>
          </p:nvSpPr>
          <p:spPr>
            <a:xfrm flipV="1">
              <a:off x="552600" y="1080720"/>
              <a:ext cx="482400" cy="44280"/>
            </a:xfrm>
            <a:prstGeom prst="line">
              <a:avLst/>
            </a:prstGeom>
            <a:ln w="12600">
              <a:solidFill>
                <a:srgbClr val="dddddd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20" bIns="-2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468360" y="1192320"/>
              <a:ext cx="1673280" cy="0"/>
            </a:xfrm>
            <a:prstGeom prst="line">
              <a:avLst/>
            </a:prstGeom>
            <a:ln w="19080">
              <a:solidFill>
                <a:srgbClr val="333399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"/>
            <p:cNvSpPr/>
            <p:nvPr/>
          </p:nvSpPr>
          <p:spPr>
            <a:xfrm>
              <a:off x="476280" y="1157400"/>
              <a:ext cx="457200" cy="0"/>
            </a:xfrm>
            <a:prstGeom prst="line">
              <a:avLst/>
            </a:prstGeom>
            <a:ln w="12600">
              <a:solidFill>
                <a:srgbClr val="dddddd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3" name=""/>
          <p:cNvSpPr/>
          <p:nvPr/>
        </p:nvSpPr>
        <p:spPr>
          <a:xfrm>
            <a:off x="476280" y="2819520"/>
            <a:ext cx="152280" cy="152280"/>
          </a:xfrm>
          <a:prstGeom prst="line">
            <a:avLst/>
          </a:prstGeom>
          <a:ln w="9360">
            <a:solidFill>
              <a:srgbClr val="ddddd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4" name=""/>
          <p:cNvGrpSpPr/>
          <p:nvPr/>
        </p:nvGrpSpPr>
        <p:grpSpPr>
          <a:xfrm>
            <a:off x="152280" y="2793960"/>
            <a:ext cx="2076480" cy="1752480"/>
            <a:chOff x="152280" y="2793960"/>
            <a:chExt cx="2076480" cy="1752480"/>
          </a:xfrm>
        </p:grpSpPr>
        <p:grpSp>
          <p:nvGrpSpPr>
            <p:cNvPr id="65" name=""/>
            <p:cNvGrpSpPr/>
            <p:nvPr/>
          </p:nvGrpSpPr>
          <p:grpSpPr>
            <a:xfrm>
              <a:off x="152280" y="2793960"/>
              <a:ext cx="2076480" cy="1752480"/>
              <a:chOff x="152280" y="2793960"/>
              <a:chExt cx="2076480" cy="1752480"/>
            </a:xfrm>
          </p:grpSpPr>
          <p:grpSp>
            <p:nvGrpSpPr>
              <p:cNvPr id="66" name=""/>
              <p:cNvGrpSpPr/>
              <p:nvPr/>
            </p:nvGrpSpPr>
            <p:grpSpPr>
              <a:xfrm>
                <a:off x="152280" y="2793960"/>
                <a:ext cx="2076480" cy="1752480"/>
                <a:chOff x="152280" y="2793960"/>
                <a:chExt cx="2076480" cy="1752480"/>
              </a:xfrm>
            </p:grpSpPr>
            <p:grpSp>
              <p:nvGrpSpPr>
                <p:cNvPr id="67" name=""/>
                <p:cNvGrpSpPr/>
                <p:nvPr/>
              </p:nvGrpSpPr>
              <p:grpSpPr>
                <a:xfrm>
                  <a:off x="152280" y="2793960"/>
                  <a:ext cx="2076480" cy="1752480"/>
                  <a:chOff x="152280" y="2793960"/>
                  <a:chExt cx="2076480" cy="1752480"/>
                </a:xfrm>
              </p:grpSpPr>
              <p:grpSp>
                <p:nvGrpSpPr>
                  <p:cNvPr id="68" name=""/>
                  <p:cNvGrpSpPr/>
                  <p:nvPr/>
                </p:nvGrpSpPr>
                <p:grpSpPr>
                  <a:xfrm>
                    <a:off x="152280" y="2793960"/>
                    <a:ext cx="2076480" cy="1752480"/>
                    <a:chOff x="152280" y="2793960"/>
                    <a:chExt cx="2076480" cy="1752480"/>
                  </a:xfrm>
                </p:grpSpPr>
                <p:grpSp>
                  <p:nvGrpSpPr>
                    <p:cNvPr id="69" name=""/>
                    <p:cNvGrpSpPr/>
                    <p:nvPr/>
                  </p:nvGrpSpPr>
                  <p:grpSpPr>
                    <a:xfrm>
                      <a:off x="152280" y="2933640"/>
                      <a:ext cx="338400" cy="1450800"/>
                      <a:chOff x="152280" y="2933640"/>
                      <a:chExt cx="338400" cy="1450800"/>
                    </a:xfrm>
                  </p:grpSpPr>
                  <p:sp>
                    <p:nvSpPr>
                      <p:cNvPr id="70" name=""/>
                      <p:cNvSpPr/>
                      <p:nvPr/>
                    </p:nvSpPr>
                    <p:spPr>
                      <a:xfrm>
                        <a:off x="171360" y="3805200"/>
                        <a:ext cx="319320" cy="274320"/>
                      </a:xfrm>
                      <a:prstGeom prst="rect">
                        <a:avLst/>
                      </a:prstGeom>
                      <a:noFill/>
                      <a:ln w="0">
                        <a:noFill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wrap="none" anchor="t">
                        <a:spAutoFit/>
                      </a:bodyPr>
                      <a:p>
                        <a:pPr algn="ctr">
                          <a:tabLst>
                            <a:tab algn="l" pos="0"/>
                            <a:tab algn="l" pos="914400"/>
                            <a:tab algn="l" pos="1828800"/>
                            <a:tab algn="l" pos="2743200"/>
                            <a:tab algn="l" pos="3657600"/>
                            <a:tab algn="l" pos="4572000"/>
                            <a:tab algn="l" pos="5486400"/>
                            <a:tab algn="l" pos="6400800"/>
                            <a:tab algn="l" pos="7315200"/>
                            <a:tab algn="l" pos="8229600"/>
                            <a:tab algn="l" pos="9144000"/>
                            <a:tab algn="l" pos="10058400"/>
                          </a:tabLst>
                        </a:pPr>
                        <a:r>
                          <a:rPr b="1" lang="en-US" sz="1200" spc="-1" strike="noStrike">
                            <a:solidFill>
                              <a:srgbClr val="333399"/>
                            </a:solidFill>
                            <a:latin typeface="Arial"/>
                          </a:rPr>
                          <a:t>-1</a:t>
                        </a:r>
                        <a:endParaRPr b="0" lang="en-US" sz="12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71" name=""/>
                      <p:cNvSpPr/>
                      <p:nvPr/>
                    </p:nvSpPr>
                    <p:spPr>
                      <a:xfrm>
                        <a:off x="152280" y="4110120"/>
                        <a:ext cx="319320" cy="274320"/>
                      </a:xfrm>
                      <a:prstGeom prst="rect">
                        <a:avLst/>
                      </a:prstGeom>
                      <a:noFill/>
                      <a:ln w="0">
                        <a:noFill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wrap="none" anchor="t">
                        <a:spAutoFit/>
                      </a:bodyPr>
                      <a:p>
                        <a:pPr algn="ctr">
                          <a:tabLst>
                            <a:tab algn="l" pos="0"/>
                            <a:tab algn="l" pos="914400"/>
                            <a:tab algn="l" pos="1828800"/>
                            <a:tab algn="l" pos="2743200"/>
                            <a:tab algn="l" pos="3657600"/>
                            <a:tab algn="l" pos="4572000"/>
                            <a:tab algn="l" pos="5486400"/>
                            <a:tab algn="l" pos="6400800"/>
                            <a:tab algn="l" pos="7315200"/>
                            <a:tab algn="l" pos="8229600"/>
                            <a:tab algn="l" pos="9144000"/>
                            <a:tab algn="l" pos="10058400"/>
                          </a:tabLst>
                        </a:pPr>
                        <a:r>
                          <a:rPr b="1" lang="en-US" sz="1200" spc="-1" strike="noStrike">
                            <a:solidFill>
                              <a:srgbClr val="333399"/>
                            </a:solidFill>
                            <a:latin typeface="Arial"/>
                          </a:rPr>
                          <a:t>-2</a:t>
                        </a:r>
                        <a:endParaRPr b="0" lang="en-US" sz="12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72" name=""/>
                      <p:cNvSpPr/>
                      <p:nvPr/>
                    </p:nvSpPr>
                    <p:spPr>
                      <a:xfrm>
                        <a:off x="218880" y="2933640"/>
                        <a:ext cx="268920" cy="274320"/>
                      </a:xfrm>
                      <a:prstGeom prst="rect">
                        <a:avLst/>
                      </a:prstGeom>
                      <a:noFill/>
                      <a:ln w="0">
                        <a:noFill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wrap="none" anchor="t">
                        <a:spAutoFit/>
                      </a:bodyPr>
                      <a:p>
                        <a:pPr algn="ctr">
                          <a:tabLst>
                            <a:tab algn="l" pos="0"/>
                            <a:tab algn="l" pos="914400"/>
                            <a:tab algn="l" pos="1828800"/>
                            <a:tab algn="l" pos="2743200"/>
                            <a:tab algn="l" pos="3657600"/>
                            <a:tab algn="l" pos="4572000"/>
                            <a:tab algn="l" pos="5486400"/>
                            <a:tab algn="l" pos="6400800"/>
                            <a:tab algn="l" pos="7315200"/>
                            <a:tab algn="l" pos="8229600"/>
                            <a:tab algn="l" pos="9144000"/>
                            <a:tab algn="l" pos="10058400"/>
                          </a:tabLst>
                        </a:pPr>
                        <a:r>
                          <a:rPr b="1" lang="en-US" sz="1200" spc="-1" strike="noStrike">
                            <a:solidFill>
                              <a:srgbClr val="333399"/>
                            </a:solidFill>
                            <a:latin typeface="Arial"/>
                          </a:rPr>
                          <a:t>2</a:t>
                        </a:r>
                        <a:endParaRPr b="0" lang="en-US" sz="12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73" name=""/>
                      <p:cNvSpPr/>
                      <p:nvPr/>
                    </p:nvSpPr>
                    <p:spPr>
                      <a:xfrm>
                        <a:off x="218880" y="3254400"/>
                        <a:ext cx="268920" cy="274320"/>
                      </a:xfrm>
                      <a:prstGeom prst="rect">
                        <a:avLst/>
                      </a:prstGeom>
                      <a:noFill/>
                      <a:ln w="0">
                        <a:noFill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wrap="none" anchor="t">
                        <a:spAutoFit/>
                      </a:bodyPr>
                      <a:p>
                        <a:pPr algn="ctr">
                          <a:tabLst>
                            <a:tab algn="l" pos="0"/>
                            <a:tab algn="l" pos="914400"/>
                            <a:tab algn="l" pos="1828800"/>
                            <a:tab algn="l" pos="2743200"/>
                            <a:tab algn="l" pos="3657600"/>
                            <a:tab algn="l" pos="4572000"/>
                            <a:tab algn="l" pos="5486400"/>
                            <a:tab algn="l" pos="6400800"/>
                            <a:tab algn="l" pos="7315200"/>
                            <a:tab algn="l" pos="8229600"/>
                            <a:tab algn="l" pos="9144000"/>
                            <a:tab algn="l" pos="10058400"/>
                          </a:tabLst>
                        </a:pPr>
                        <a:r>
                          <a:rPr b="1" lang="en-US" sz="1200" spc="-1" strike="noStrike">
                            <a:solidFill>
                              <a:srgbClr val="333399"/>
                            </a:solidFill>
                            <a:latin typeface="Arial"/>
                          </a:rPr>
                          <a:t>1</a:t>
                        </a:r>
                        <a:endParaRPr b="0" lang="en-US" sz="12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</p:grpSp>
                <p:pic>
                  <p:nvPicPr>
                    <p:cNvPr id="74" name="" descr=""/>
                    <p:cNvPicPr/>
                    <p:nvPr/>
                  </p:nvPicPr>
                  <p:blipFill>
                    <a:blip r:embed="rId5"/>
                    <a:srcRect l="49466" t="33790" r="25271" b="33790"/>
                    <a:stretch/>
                  </p:blipFill>
                  <p:spPr>
                    <a:xfrm>
                      <a:off x="399960" y="2793960"/>
                      <a:ext cx="1828800" cy="175248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  <p:sp>
                  <p:nvSpPr>
                    <p:cNvPr id="75" name=""/>
                    <p:cNvSpPr/>
                    <p:nvPr/>
                  </p:nvSpPr>
                  <p:spPr>
                    <a:xfrm>
                      <a:off x="533520" y="3727440"/>
                      <a:ext cx="153720" cy="304920"/>
                    </a:xfrm>
                    <a:prstGeom prst="upArrow">
                      <a:avLst>
                        <a:gd name="adj1" fmla="val 50000"/>
                        <a:gd name="adj2" fmla="val 49590"/>
                      </a:avLst>
                    </a:prstGeom>
                    <a:solidFill>
                      <a:srgbClr val="ff3300"/>
                    </a:solidFill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90000" rIns="90000" tIns="46800" bIns="46800" anchor="ctr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76" name=""/>
                    <p:cNvSpPr/>
                    <p:nvPr/>
                  </p:nvSpPr>
                  <p:spPr>
                    <a:xfrm>
                      <a:off x="473400" y="4027320"/>
                      <a:ext cx="898200" cy="30492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nl-NL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5-24 hr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  <p:sp>
                <p:nvSpPr>
                  <p:cNvPr id="77" name=""/>
                  <p:cNvSpPr/>
                  <p:nvPr/>
                </p:nvSpPr>
                <p:spPr>
                  <a:xfrm>
                    <a:off x="527040" y="2908080"/>
                    <a:ext cx="380880" cy="76320"/>
                  </a:xfrm>
                  <a:prstGeom prst="rect">
                    <a:avLst/>
                  </a:prstGeom>
                  <a:solidFill>
                    <a:srgbClr val="ffffff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29520" bIns="2952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78" name=""/>
                <p:cNvSpPr/>
                <p:nvPr/>
              </p:nvSpPr>
              <p:spPr>
                <a:xfrm>
                  <a:off x="666720" y="2844720"/>
                  <a:ext cx="152640" cy="152280"/>
                </a:xfrm>
                <a:prstGeom prst="line">
                  <a:avLst/>
                </a:prstGeom>
                <a:ln w="9360">
                  <a:solidFill>
                    <a:srgbClr val="dddddd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9" name=""/>
                <p:cNvSpPr/>
                <p:nvPr/>
              </p:nvSpPr>
              <p:spPr>
                <a:xfrm>
                  <a:off x="590760" y="2876400"/>
                  <a:ext cx="152280" cy="152280"/>
                </a:xfrm>
                <a:prstGeom prst="line">
                  <a:avLst/>
                </a:prstGeom>
                <a:ln w="9360">
                  <a:solidFill>
                    <a:srgbClr val="dddddd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80" name=""/>
              <p:cNvSpPr/>
              <p:nvPr/>
            </p:nvSpPr>
            <p:spPr>
              <a:xfrm>
                <a:off x="520560" y="2952720"/>
                <a:ext cx="381240" cy="0"/>
              </a:xfrm>
              <a:prstGeom prst="line">
                <a:avLst/>
              </a:prstGeom>
              <a:ln w="9360">
                <a:solidFill>
                  <a:srgbClr val="dddddd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81" name=""/>
            <p:cNvSpPr/>
            <p:nvPr/>
          </p:nvSpPr>
          <p:spPr>
            <a:xfrm>
              <a:off x="1317240" y="4241880"/>
              <a:ext cx="8359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200" spc="-1" strike="noStrike">
                  <a:solidFill>
                    <a:srgbClr val="003399"/>
                  </a:solidFill>
                  <a:latin typeface="Arial"/>
                </a:rPr>
                <a:t>78 gene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82" name=""/>
          <p:cNvSpPr/>
          <p:nvPr/>
        </p:nvSpPr>
        <p:spPr>
          <a:xfrm>
            <a:off x="2068560" y="649440"/>
            <a:ext cx="2230560" cy="304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400" spc="-1" strike="noStrike">
                <a:solidFill>
                  <a:srgbClr val="000000"/>
                </a:solidFill>
                <a:latin typeface="Arial"/>
              </a:rPr>
              <a:t>0.5  1    2    4    6    24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nl-NL" sz="1400" spc="-1" strike="noStrike">
                <a:solidFill>
                  <a:srgbClr val="000000"/>
                </a:solidFill>
                <a:latin typeface="Arial"/>
              </a:rPr>
              <a:t>hr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"/>
          <p:cNvSpPr/>
          <p:nvPr/>
        </p:nvSpPr>
        <p:spPr>
          <a:xfrm>
            <a:off x="6805440" y="649440"/>
            <a:ext cx="2230560" cy="304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400" spc="-1" strike="noStrike">
                <a:solidFill>
                  <a:srgbClr val="000000"/>
                </a:solidFill>
                <a:latin typeface="Arial"/>
              </a:rPr>
              <a:t>0.5  1    2    4    6    24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nl-NL" sz="1400" spc="-1" strike="noStrike">
                <a:solidFill>
                  <a:srgbClr val="000000"/>
                </a:solidFill>
                <a:latin typeface="Arial"/>
              </a:rPr>
              <a:t>hr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"/>
          <p:cNvSpPr/>
          <p:nvPr/>
        </p:nvSpPr>
        <p:spPr>
          <a:xfrm>
            <a:off x="5105520" y="-152280"/>
            <a:ext cx="3060720" cy="99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Early genes</a:t>
            </a:r>
            <a:r>
              <a:rPr b="0" lang="nl-NL" sz="1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"/>
          <p:cNvSpPr/>
          <p:nvPr/>
        </p:nvSpPr>
        <p:spPr>
          <a:xfrm>
            <a:off x="6946920" y="1733400"/>
            <a:ext cx="2209680" cy="821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Myc, Pawr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VegfA, Bdnf, Cx3cl1, Areg, Itga5, Tnfrsf12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Map2k3, Bcl10, Pim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"/>
          <p:cNvSpPr/>
          <p:nvPr/>
        </p:nvSpPr>
        <p:spPr>
          <a:xfrm>
            <a:off x="6946920" y="3809880"/>
            <a:ext cx="1981080" cy="1211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Klf5, S1P</a:t>
            </a:r>
            <a:r>
              <a:rPr b="0" lang="nl-NL" sz="1200" spc="-1" strike="noStrike" baseline="-25000">
                <a:solidFill>
                  <a:srgbClr val="000000"/>
                </a:solidFill>
                <a:latin typeface="Arial"/>
              </a:rPr>
              <a:t>2</a:t>
            </a: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, Flt1, Pdlim5, Fhl1,Thbs1, Pdgfa, Ngfb, Actg2, Vcl, Sorbs1, Timp3, Rock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7" name="" descr=""/>
          <p:cNvPicPr/>
          <p:nvPr/>
        </p:nvPicPr>
        <p:blipFill>
          <a:blip r:embed="rId6"/>
          <a:srcRect l="0" t="49554" r="0" b="0"/>
          <a:stretch/>
        </p:blipFill>
        <p:spPr>
          <a:xfrm>
            <a:off x="6815160" y="952560"/>
            <a:ext cx="2133720" cy="814320"/>
          </a:xfrm>
          <a:prstGeom prst="rect">
            <a:avLst/>
          </a:prstGeom>
          <a:ln w="0">
            <a:noFill/>
          </a:ln>
        </p:spPr>
      </p:pic>
      <p:pic>
        <p:nvPicPr>
          <p:cNvPr id="88" name="" descr=""/>
          <p:cNvPicPr/>
          <p:nvPr/>
        </p:nvPicPr>
        <p:blipFill>
          <a:blip r:embed="rId7"/>
          <a:srcRect l="0" t="45951" r="0" b="0"/>
          <a:stretch/>
        </p:blipFill>
        <p:spPr>
          <a:xfrm>
            <a:off x="6800760" y="2820960"/>
            <a:ext cx="2133720" cy="981000"/>
          </a:xfrm>
          <a:prstGeom prst="rect">
            <a:avLst/>
          </a:prstGeom>
          <a:ln w="0">
            <a:noFill/>
          </a:ln>
        </p:spPr>
      </p:pic>
      <p:grpSp>
        <p:nvGrpSpPr>
          <p:cNvPr id="89" name=""/>
          <p:cNvGrpSpPr/>
          <p:nvPr/>
        </p:nvGrpSpPr>
        <p:grpSpPr>
          <a:xfrm>
            <a:off x="4737240" y="2743200"/>
            <a:ext cx="2050920" cy="1828800"/>
            <a:chOff x="4737240" y="2743200"/>
            <a:chExt cx="2050920" cy="1828800"/>
          </a:xfrm>
        </p:grpSpPr>
        <p:grpSp>
          <p:nvGrpSpPr>
            <p:cNvPr id="90" name=""/>
            <p:cNvGrpSpPr/>
            <p:nvPr/>
          </p:nvGrpSpPr>
          <p:grpSpPr>
            <a:xfrm>
              <a:off x="4737240" y="2743200"/>
              <a:ext cx="2050920" cy="1828800"/>
              <a:chOff x="4737240" y="2743200"/>
              <a:chExt cx="2050920" cy="1828800"/>
            </a:xfrm>
          </p:grpSpPr>
          <p:pic>
            <p:nvPicPr>
              <p:cNvPr id="91" name="" descr=""/>
              <p:cNvPicPr/>
              <p:nvPr/>
            </p:nvPicPr>
            <p:blipFill>
              <a:blip r:embed="rId8"/>
              <a:srcRect l="25360" t="0" r="50449" b="66272"/>
              <a:stretch/>
            </p:blipFill>
            <p:spPr>
              <a:xfrm>
                <a:off x="5008680" y="2743200"/>
                <a:ext cx="1746000" cy="18288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92" name=""/>
              <p:cNvSpPr/>
              <p:nvPr/>
            </p:nvSpPr>
            <p:spPr>
              <a:xfrm>
                <a:off x="6334200" y="3962520"/>
                <a:ext cx="154080" cy="304920"/>
              </a:xfrm>
              <a:prstGeom prst="upArrow">
                <a:avLst>
                  <a:gd name="adj1" fmla="val 50000"/>
                  <a:gd name="adj2" fmla="val 49474"/>
                </a:avLst>
              </a:prstGeom>
              <a:solidFill>
                <a:srgbClr val="00cc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" name=""/>
              <p:cNvSpPr/>
              <p:nvPr/>
            </p:nvSpPr>
            <p:spPr>
              <a:xfrm>
                <a:off x="6197760" y="4218120"/>
                <a:ext cx="590400" cy="304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nl-NL" sz="1400" spc="-1" strike="noStrike">
                    <a:solidFill>
                      <a:srgbClr val="000000"/>
                    </a:solidFill>
                    <a:latin typeface="Arial"/>
                  </a:rPr>
                  <a:t>24 hr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" name=""/>
              <p:cNvSpPr/>
              <p:nvPr/>
            </p:nvSpPr>
            <p:spPr>
              <a:xfrm>
                <a:off x="5554800" y="3505320"/>
                <a:ext cx="149040" cy="304920"/>
              </a:xfrm>
              <a:prstGeom prst="upArrow">
                <a:avLst>
                  <a:gd name="adj1" fmla="val 50000"/>
                  <a:gd name="adj2" fmla="val 51147"/>
                </a:avLst>
              </a:prstGeom>
              <a:solidFill>
                <a:srgbClr val="ff33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" name=""/>
              <p:cNvSpPr/>
              <p:nvPr/>
            </p:nvSpPr>
            <p:spPr>
              <a:xfrm>
                <a:off x="5398920" y="3778200"/>
                <a:ext cx="541800" cy="304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nl-NL" sz="14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nl-NL" sz="1400" spc="-1" strike="noStrike">
                    <a:solidFill>
                      <a:srgbClr val="000000"/>
                    </a:solidFill>
                    <a:latin typeface="Arial"/>
                  </a:rPr>
                  <a:t>2 hr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" name=""/>
              <p:cNvSpPr/>
              <p:nvPr/>
            </p:nvSpPr>
            <p:spPr>
              <a:xfrm>
                <a:off x="5021280" y="3329280"/>
                <a:ext cx="1673280" cy="0"/>
              </a:xfrm>
              <a:prstGeom prst="line">
                <a:avLst/>
              </a:prstGeom>
              <a:ln w="19080">
                <a:solidFill>
                  <a:srgbClr val="333399"/>
                </a:solidFill>
                <a:prstDash val="dash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" name=""/>
              <p:cNvSpPr/>
              <p:nvPr/>
            </p:nvSpPr>
            <p:spPr>
              <a:xfrm>
                <a:off x="4743360" y="3802320"/>
                <a:ext cx="319320" cy="274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333399"/>
                    </a:solidFill>
                    <a:latin typeface="Arial"/>
                  </a:rPr>
                  <a:t>-1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" name=""/>
              <p:cNvSpPr/>
              <p:nvPr/>
            </p:nvSpPr>
            <p:spPr>
              <a:xfrm>
                <a:off x="4737240" y="4106880"/>
                <a:ext cx="319320" cy="274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333399"/>
                    </a:solidFill>
                    <a:latin typeface="Arial"/>
                  </a:rPr>
                  <a:t>-2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" name=""/>
              <p:cNvSpPr/>
              <p:nvPr/>
            </p:nvSpPr>
            <p:spPr>
              <a:xfrm>
                <a:off x="4790880" y="2930760"/>
                <a:ext cx="268920" cy="274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333399"/>
                    </a:solidFill>
                    <a:latin typeface="Arial"/>
                  </a:rPr>
                  <a:t>2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" name=""/>
              <p:cNvSpPr/>
              <p:nvPr/>
            </p:nvSpPr>
            <p:spPr>
              <a:xfrm>
                <a:off x="4790880" y="3251160"/>
                <a:ext cx="268920" cy="274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333399"/>
                    </a:solidFill>
                    <a:latin typeface="Arial"/>
                  </a:rPr>
                  <a:t>1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01" name=""/>
            <p:cNvSpPr/>
            <p:nvPr/>
          </p:nvSpPr>
          <p:spPr>
            <a:xfrm>
              <a:off x="5062680" y="4025880"/>
              <a:ext cx="1673280" cy="0"/>
            </a:xfrm>
            <a:prstGeom prst="line">
              <a:avLst/>
            </a:prstGeom>
            <a:ln w="19080">
              <a:solidFill>
                <a:srgbClr val="333399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"/>
            <p:cNvSpPr/>
            <p:nvPr/>
          </p:nvSpPr>
          <p:spPr>
            <a:xfrm>
              <a:off x="5032080" y="2838600"/>
              <a:ext cx="835920" cy="2764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200" spc="-1" strike="noStrike">
                  <a:solidFill>
                    <a:srgbClr val="003399"/>
                  </a:solidFill>
                  <a:latin typeface="Arial"/>
                </a:rPr>
                <a:t>62 gene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03" name=""/>
          <p:cNvGrpSpPr/>
          <p:nvPr/>
        </p:nvGrpSpPr>
        <p:grpSpPr>
          <a:xfrm>
            <a:off x="4737240" y="909720"/>
            <a:ext cx="2038320" cy="1812960"/>
            <a:chOff x="4737240" y="909720"/>
            <a:chExt cx="2038320" cy="1812960"/>
          </a:xfrm>
        </p:grpSpPr>
        <p:grpSp>
          <p:nvGrpSpPr>
            <p:cNvPr id="104" name=""/>
            <p:cNvGrpSpPr/>
            <p:nvPr/>
          </p:nvGrpSpPr>
          <p:grpSpPr>
            <a:xfrm>
              <a:off x="4737240" y="909720"/>
              <a:ext cx="2038320" cy="1812960"/>
              <a:chOff x="4737240" y="909720"/>
              <a:chExt cx="2038320" cy="1812960"/>
            </a:xfrm>
          </p:grpSpPr>
          <p:pic>
            <p:nvPicPr>
              <p:cNvPr id="105" name="" descr=""/>
              <p:cNvPicPr/>
              <p:nvPr/>
            </p:nvPicPr>
            <p:blipFill>
              <a:blip r:embed="rId9"/>
              <a:srcRect l="0" t="0" r="74733" b="66272"/>
              <a:stretch/>
            </p:blipFill>
            <p:spPr>
              <a:xfrm>
                <a:off x="4946760" y="909720"/>
                <a:ext cx="1828800" cy="181296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06" name=""/>
              <p:cNvSpPr/>
              <p:nvPr/>
            </p:nvSpPr>
            <p:spPr>
              <a:xfrm>
                <a:off x="5508720" y="1408320"/>
                <a:ext cx="149040" cy="304920"/>
              </a:xfrm>
              <a:prstGeom prst="upArrow">
                <a:avLst>
                  <a:gd name="adj1" fmla="val 50000"/>
                  <a:gd name="adj2" fmla="val 51147"/>
                </a:avLst>
              </a:prstGeom>
              <a:solidFill>
                <a:srgbClr val="ff33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" name=""/>
              <p:cNvSpPr/>
              <p:nvPr/>
            </p:nvSpPr>
            <p:spPr>
              <a:xfrm>
                <a:off x="5426640" y="1740240"/>
                <a:ext cx="491400" cy="304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nl-NL" sz="1400" spc="-1" strike="noStrike">
                    <a:solidFill>
                      <a:srgbClr val="000000"/>
                    </a:solidFill>
                    <a:latin typeface="Arial"/>
                  </a:rPr>
                  <a:t>2 hr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" name=""/>
              <p:cNvSpPr/>
              <p:nvPr/>
            </p:nvSpPr>
            <p:spPr>
              <a:xfrm>
                <a:off x="4749840" y="1967040"/>
                <a:ext cx="319320" cy="274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333399"/>
                    </a:solidFill>
                    <a:latin typeface="Arial"/>
                  </a:rPr>
                  <a:t>-1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" name=""/>
              <p:cNvSpPr/>
              <p:nvPr/>
            </p:nvSpPr>
            <p:spPr>
              <a:xfrm>
                <a:off x="4737240" y="2271960"/>
                <a:ext cx="319320" cy="274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333399"/>
                    </a:solidFill>
                    <a:latin typeface="Arial"/>
                  </a:rPr>
                  <a:t>-2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" name=""/>
              <p:cNvSpPr/>
              <p:nvPr/>
            </p:nvSpPr>
            <p:spPr>
              <a:xfrm>
                <a:off x="4778280" y="1103400"/>
                <a:ext cx="268920" cy="274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333399"/>
                    </a:solidFill>
                    <a:latin typeface="Arial"/>
                  </a:rPr>
                  <a:t>2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" name=""/>
              <p:cNvSpPr/>
              <p:nvPr/>
            </p:nvSpPr>
            <p:spPr>
              <a:xfrm>
                <a:off x="4778280" y="1425600"/>
                <a:ext cx="268920" cy="274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333399"/>
                    </a:solidFill>
                    <a:latin typeface="Arial"/>
                  </a:rPr>
                  <a:t>1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" name=""/>
              <p:cNvSpPr/>
              <p:nvPr/>
            </p:nvSpPr>
            <p:spPr>
              <a:xfrm>
                <a:off x="5051520" y="1246320"/>
                <a:ext cx="1673280" cy="0"/>
              </a:xfrm>
              <a:prstGeom prst="line">
                <a:avLst/>
              </a:prstGeom>
              <a:ln w="19080">
                <a:solidFill>
                  <a:srgbClr val="333399"/>
                </a:solidFill>
                <a:prstDash val="dash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13" name=""/>
            <p:cNvSpPr/>
            <p:nvPr/>
          </p:nvSpPr>
          <p:spPr>
            <a:xfrm>
              <a:off x="5905440" y="2405160"/>
              <a:ext cx="8359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200" spc="-1" strike="noStrike">
                  <a:solidFill>
                    <a:srgbClr val="003399"/>
                  </a:solidFill>
                  <a:latin typeface="Arial"/>
                </a:rPr>
                <a:t>51 gene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"/>
            <p:cNvSpPr/>
            <p:nvPr/>
          </p:nvSpPr>
          <p:spPr>
            <a:xfrm>
              <a:off x="5080320" y="1041480"/>
              <a:ext cx="533160" cy="1526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15" name=""/>
          <p:cNvSpPr/>
          <p:nvPr/>
        </p:nvSpPr>
        <p:spPr>
          <a:xfrm>
            <a:off x="5791320" y="6019920"/>
            <a:ext cx="289548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400" spc="-1" strike="noStrike">
                <a:solidFill>
                  <a:srgbClr val="000000"/>
                </a:solidFill>
                <a:latin typeface="Arial"/>
              </a:rPr>
              <a:t>Additional file 2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"/>
          <p:cNvSpPr/>
          <p:nvPr/>
        </p:nvSpPr>
        <p:spPr>
          <a:xfrm>
            <a:off x="0" y="4648320"/>
            <a:ext cx="2209680" cy="702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      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0.5  1    2    4    6   24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              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(hrs LPA)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                                      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8-11T09:39:15Z</dcterms:created>
  <dc:creator>w.moolenaar</dc:creator>
  <dc:description/>
  <dc:language>en-US</dc:language>
  <cp:lastModifiedBy>w.moolenaar</cp:lastModifiedBy>
  <dcterms:modified xsi:type="dcterms:W3CDTF">2008-08-11T09:39:43Z</dcterms:modified>
  <cp:revision>1</cp:revision>
  <dc:subject/>
  <dc:title>Slide 1</dc:title>
</cp:coreProperties>
</file>